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9" r:id="rId3"/>
    <p:sldId id="257" r:id="rId4"/>
    <p:sldId id="258" r:id="rId5"/>
    <p:sldId id="266" r:id="rId6"/>
    <p:sldId id="260" r:id="rId7"/>
    <p:sldId id="261" r:id="rId8"/>
    <p:sldId id="262" r:id="rId9"/>
    <p:sldId id="263" r:id="rId1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71" autoAdjust="0"/>
    <p:restoredTop sz="94660"/>
  </p:normalViewPr>
  <p:slideViewPr>
    <p:cSldViewPr snapToGrid="0">
      <p:cViewPr>
        <p:scale>
          <a:sx n="125" d="100"/>
          <a:sy n="125" d="100"/>
        </p:scale>
        <p:origin x="79" y="-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8BB4-E6EB-442A-99F8-123FFE1B4491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D1A9-3C9B-4198-929C-2410254E9F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66474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8BB4-E6EB-442A-99F8-123FFE1B4491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D1A9-3C9B-4198-929C-2410254E9F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89545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8BB4-E6EB-442A-99F8-123FFE1B4491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D1A9-3C9B-4198-929C-2410254E9F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58786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8BB4-E6EB-442A-99F8-123FFE1B4491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D1A9-3C9B-4198-929C-2410254E9F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1224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8BB4-E6EB-442A-99F8-123FFE1B4491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D1A9-3C9B-4198-929C-2410254E9F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60884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8BB4-E6EB-442A-99F8-123FFE1B4491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D1A9-3C9B-4198-929C-2410254E9F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8620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8BB4-E6EB-442A-99F8-123FFE1B4491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D1A9-3C9B-4198-929C-2410254E9F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4181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8BB4-E6EB-442A-99F8-123FFE1B4491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D1A9-3C9B-4198-929C-2410254E9F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47150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8BB4-E6EB-442A-99F8-123FFE1B4491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D1A9-3C9B-4198-929C-2410254E9F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54080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8BB4-E6EB-442A-99F8-123FFE1B4491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D1A9-3C9B-4198-929C-2410254E9F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26718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C8BB4-E6EB-442A-99F8-123FFE1B4491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D1A9-3C9B-4198-929C-2410254E9F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05085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1C8BB4-E6EB-442A-99F8-123FFE1B4491}" type="datetimeFigureOut">
              <a:rPr lang="zh-CN" altLang="en-US" smtClean="0"/>
              <a:t>2022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F5D1A9-3C9B-4198-929C-2410254E9F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49613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2F038ED2-59E4-470B-B53C-ECA968A4BD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0" y="103414"/>
            <a:ext cx="6857998" cy="969917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389BAE8A-787B-4AC8-9F6B-B28C2AF64B62}"/>
              </a:ext>
            </a:extLst>
          </p:cNvPr>
          <p:cNvSpPr txBox="1"/>
          <p:nvPr/>
        </p:nvSpPr>
        <p:spPr>
          <a:xfrm>
            <a:off x="691242" y="5166724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74199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58F7D60C-7C47-465A-8934-6A5A1D5D9BF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0" y="103415"/>
            <a:ext cx="6857997" cy="9699167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F9A31917-7581-4485-8CEB-E989FAD738EF}"/>
              </a:ext>
            </a:extLst>
          </p:cNvPr>
          <p:cNvSpPr txBox="1"/>
          <p:nvPr/>
        </p:nvSpPr>
        <p:spPr>
          <a:xfrm>
            <a:off x="0" y="6748399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97564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E6A36E9-B2EB-4862-8E5E-F86A746AAB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0" y="103415"/>
            <a:ext cx="6857998" cy="9699168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FBEC3C1F-8737-444C-8172-9E797B6D4921}"/>
              </a:ext>
            </a:extLst>
          </p:cNvPr>
          <p:cNvSpPr txBox="1"/>
          <p:nvPr/>
        </p:nvSpPr>
        <p:spPr>
          <a:xfrm>
            <a:off x="1511642" y="5404913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0508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3CB7BF00-7A26-4B6E-9F58-6DF79BE5B5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0" y="0"/>
            <a:ext cx="6857999" cy="969917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6B525281-E40B-4CF5-90DF-EA722E6BEC94}"/>
              </a:ext>
            </a:extLst>
          </p:cNvPr>
          <p:cNvSpPr txBox="1"/>
          <p:nvPr/>
        </p:nvSpPr>
        <p:spPr>
          <a:xfrm>
            <a:off x="1009384" y="3166956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. S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95062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95C6F9E4-D6A6-4559-B707-BC70D403CF9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0" y="103414"/>
            <a:ext cx="6857999" cy="969917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6B525281-E40B-4CF5-90DF-EA722E6BEC94}"/>
              </a:ext>
            </a:extLst>
          </p:cNvPr>
          <p:cNvSpPr txBox="1"/>
          <p:nvPr/>
        </p:nvSpPr>
        <p:spPr>
          <a:xfrm>
            <a:off x="1429917" y="5293722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. S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76731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857F676-B66E-4D4E-9F65-9658683DC9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0" y="103415"/>
            <a:ext cx="6857996" cy="9699167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57DBCC61-5D30-4F7F-8D59-B32031794386}"/>
              </a:ext>
            </a:extLst>
          </p:cNvPr>
          <p:cNvSpPr txBox="1"/>
          <p:nvPr/>
        </p:nvSpPr>
        <p:spPr>
          <a:xfrm>
            <a:off x="193855" y="6970369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. S6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40115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0721F07-D948-442F-B843-AEBCE7965FF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15470"/>
            <a:ext cx="6858000" cy="8875059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4040A8AC-BC61-4A14-8F89-452EF79BF244}"/>
              </a:ext>
            </a:extLst>
          </p:cNvPr>
          <p:cNvSpPr txBox="1"/>
          <p:nvPr/>
        </p:nvSpPr>
        <p:spPr>
          <a:xfrm>
            <a:off x="847775" y="5083007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. S7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05418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3856E93-30CE-4179-BF2A-3F937082C99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0" y="103414"/>
            <a:ext cx="6857999" cy="969917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F64AD51C-0858-48F0-8353-9BF7F1B76F33}"/>
              </a:ext>
            </a:extLst>
          </p:cNvPr>
          <p:cNvSpPr txBox="1"/>
          <p:nvPr/>
        </p:nvSpPr>
        <p:spPr>
          <a:xfrm>
            <a:off x="665296" y="4676000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. S8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662031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B99A89D-66C4-40EE-9CCA-87C6961BBED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0" y="103415"/>
            <a:ext cx="6857998" cy="9699168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523B29CB-28A1-4F22-922D-DD837A9B2B31}"/>
              </a:ext>
            </a:extLst>
          </p:cNvPr>
          <p:cNvSpPr txBox="1"/>
          <p:nvPr/>
        </p:nvSpPr>
        <p:spPr>
          <a:xfrm>
            <a:off x="1527314" y="5529116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. S9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06532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04</TotalTime>
  <Words>27</Words>
  <Application>Microsoft Office PowerPoint</Application>
  <PresentationFormat>A4 纸张(210x297 毫米)</PresentationFormat>
  <Paragraphs>9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o zhixue</dc:creator>
  <cp:lastModifiedBy>zhao zhixue</cp:lastModifiedBy>
  <cp:revision>25</cp:revision>
  <dcterms:created xsi:type="dcterms:W3CDTF">2022-04-07T06:51:14Z</dcterms:created>
  <dcterms:modified xsi:type="dcterms:W3CDTF">2022-05-30T15:25:59Z</dcterms:modified>
</cp:coreProperties>
</file>